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67F155A-D4E8-0E6D-457F-0177CDCCF72F}" name="Colin Leitzinger, Christelle M" initials="CC" userId="S::Christelle.ColinLeitzinger@moffitt.org::c6c4e1a0-f7c2-4d57-9e03-d524d75f76bc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897FF"/>
    <a:srgbClr val="23A4FF"/>
    <a:srgbClr val="12A9F2"/>
    <a:srgbClr val="A17158"/>
    <a:srgbClr val="D1B71A"/>
    <a:srgbClr val="E1FDD8"/>
    <a:srgbClr val="FB9990"/>
    <a:srgbClr val="DD6923"/>
    <a:srgbClr val="E28D2F"/>
    <a:srgbClr val="1E83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605"/>
    <p:restoredTop sz="94762"/>
  </p:normalViewPr>
  <p:slideViewPr>
    <p:cSldViewPr snapToGrid="0">
      <p:cViewPr varScale="1">
        <p:scale>
          <a:sx n="121" d="100"/>
          <a:sy n="121" d="100"/>
        </p:scale>
        <p:origin x="48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BD8844-DD04-FF40-AA93-FE787FCD3785}" type="datetimeFigureOut">
              <a:rPr lang="en-US" smtClean="0"/>
              <a:t>8/2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4A0BFD-B165-494E-8513-15835A804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3299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4A0BFD-B165-494E-8513-15835A80437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9707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D115C-AABD-2521-5C52-5BDDBC8AF9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31163A-14F6-C635-7097-4AC0A24B74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F9EB57-F45C-5367-96B3-A3E7EC2EB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F5C6AF-FB3B-2A9D-CA70-C3998EE07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6B13D1-D251-CF0C-4E85-D1F2AD9461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233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D6BDC1-6042-26F4-AF93-BF6D85764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50BF63-A337-B49D-4A09-C66B9ECE3B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D0C1D1-2158-0F99-BF50-61AEE4F60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2EADB9-592C-9843-F2A5-8484CB0C3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983975-F5F7-D5F1-9269-FFCBE137B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767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5C83D2-1EEC-8553-4FFB-19F81DA0DC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8F5E70-4358-91FE-5F9E-1515BB2163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B601F7-DFF1-125A-97FF-9DE2AC48C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D454FC-4BCE-843A-D040-ED9BB95D0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C6CE62-36E2-7BBB-0F3A-41AE53B28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661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AD3F1-D663-430D-FDEF-7D4C30FA7B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37206C-9B15-E783-0E2D-D7FB91B839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90DD39-45E6-B27E-F004-5CC06D3A2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03E417-5C5A-A0D3-80DA-9A4DB358D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5D16D5-367C-019D-2FDD-C988B7106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778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8DEED4-BB40-A06A-072F-3CC6933792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8F6448-3885-9A11-9D5A-F72C410796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76D7B8-C3C0-FBAA-D506-5294F4AEEA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3D888E-95FC-C441-65FB-CC2AEDE3F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67974E-0A65-A1D3-0892-18EDA74F4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198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C748E5-FEF1-C79B-2750-B8BE3058E7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B2C4E4-9DFD-BDA4-C7C4-BEFF92A28B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B2C97E-1F06-5D28-D393-F5FFD90FB7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13FBC7-E531-BD63-30EF-BE1EC28D0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022864-B7C3-E2F1-597C-7880A2E6B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24F6C6-8240-934C-201A-9E2A42FCB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88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CC884C-0EA5-7255-F0F6-3899637F9E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3EE54D-D24A-B1E2-A786-0FF13DF799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A4ADB0-E5BD-AB11-CEB8-185DFB88C8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8CD3782-815C-6AE5-68C7-80F7619586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E2140A-FFDC-F001-11E4-F676179EC3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CB6661-2A97-3108-79B6-32B424512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911FADD-0EE7-483D-C7AD-B32A72409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BEE2EF6-D410-C766-5CFA-D053377D2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540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3D7188-DDA8-4651-6575-1930ADCAFA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485793-DF26-725D-42FF-7653E6320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A00FD52-081D-77BB-FCFB-6E97B8C07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56C674-BCBA-F29A-CB74-06FBCD1A2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4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80F6522-AC32-D2A9-2B1E-AE76F5AC9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BEDD69-A394-4462-50AE-620AF61B1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EAB6FF-2DFA-A406-64D6-FF00CFC85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318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4DC00C-7A2D-98C7-02B3-DD67792362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B8702F-5C2C-4AE5-275E-85C4616241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0F24207-1591-68D5-788C-239B61070F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229117-4708-9279-087C-E42414E04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2AA098-0522-8F67-B826-7D4EF5AC0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96CF97-E468-1549-AC6A-924245B58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17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D757EF-F7D5-79A2-77A4-434F027A88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963AA4A-8502-6C7F-B20B-9649ADFF33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AF2795-C058-B2FA-43AE-0624E6D761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FC2F82-1F0D-BB20-9D46-534C73A4E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72611A-8187-3B5E-3A64-53CC760D9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3A9AD0-344D-A444-4B89-F7ECF34D0A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313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994FE0-6D78-7467-1578-2B6CD7A812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4221EC-95BB-B2F0-5A36-D8B94D6B8A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023776-7495-DAA1-8B84-A3CFCCC5588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F1221C-5AFB-234C-8099-0915A83EC902}" type="datetimeFigureOut">
              <a:rPr lang="en-US" smtClean="0"/>
              <a:t>8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B2F04D-544E-65F4-31C9-64541E74FE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36CEE3-9836-9996-36AE-85AD317732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515157-8AC8-B749-AA06-C94F95E6BA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978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>
            <a:extLst>
              <a:ext uri="{FF2B5EF4-FFF2-40B4-BE49-F238E27FC236}">
                <a16:creationId xmlns:a16="http://schemas.microsoft.com/office/drawing/2014/main" id="{CB86B641-739E-E791-EBD1-4F0E18DB80F6}"/>
              </a:ext>
            </a:extLst>
          </p:cNvPr>
          <p:cNvSpPr/>
          <p:nvPr/>
        </p:nvSpPr>
        <p:spPr>
          <a:xfrm>
            <a:off x="54290" y="407676"/>
            <a:ext cx="2195821" cy="3884804"/>
          </a:xfrm>
          <a:prstGeom prst="roundRect">
            <a:avLst/>
          </a:prstGeom>
          <a:solidFill>
            <a:srgbClr val="6DA2D2">
              <a:alpha val="30588"/>
            </a:srgbClr>
          </a:solidFill>
          <a:ln w="9525">
            <a:solidFill>
              <a:srgbClr val="6DA2D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C2D7FF"/>
              </a:solidFill>
            </a:endParaRPr>
          </a:p>
        </p:txBody>
      </p:sp>
      <p:sp>
        <p:nvSpPr>
          <p:cNvPr id="5" name="Rounded Rectangle 4">
            <a:extLst>
              <a:ext uri="{FF2B5EF4-FFF2-40B4-BE49-F238E27FC236}">
                <a16:creationId xmlns:a16="http://schemas.microsoft.com/office/drawing/2014/main" id="{C13C0961-A898-560F-7D61-4030ED18F9EE}"/>
              </a:ext>
            </a:extLst>
          </p:cNvPr>
          <p:cNvSpPr/>
          <p:nvPr/>
        </p:nvSpPr>
        <p:spPr>
          <a:xfrm>
            <a:off x="2410774" y="1321454"/>
            <a:ext cx="2256639" cy="1149992"/>
          </a:xfrm>
          <a:prstGeom prst="roundRect">
            <a:avLst/>
          </a:prstGeom>
          <a:solidFill>
            <a:srgbClr val="E28D2F">
              <a:alpha val="18824"/>
            </a:srgbClr>
          </a:solidFill>
          <a:ln w="9525"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1A91D104-AA32-4B41-513E-E0D7DFDD6545}"/>
              </a:ext>
            </a:extLst>
          </p:cNvPr>
          <p:cNvSpPr/>
          <p:nvPr/>
        </p:nvSpPr>
        <p:spPr>
          <a:xfrm>
            <a:off x="4830575" y="1321454"/>
            <a:ext cx="2132964" cy="3243999"/>
          </a:xfrm>
          <a:prstGeom prst="roundRect">
            <a:avLst/>
          </a:prstGeom>
          <a:solidFill>
            <a:srgbClr val="E1FDD8">
              <a:alpha val="83137"/>
            </a:srgbClr>
          </a:solidFill>
          <a:ln w="9525"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ounded Rectangle 9">
            <a:extLst>
              <a:ext uri="{FF2B5EF4-FFF2-40B4-BE49-F238E27FC236}">
                <a16:creationId xmlns:a16="http://schemas.microsoft.com/office/drawing/2014/main" id="{B9FAC223-2290-2C45-9925-BDE8F61DD07E}"/>
              </a:ext>
            </a:extLst>
          </p:cNvPr>
          <p:cNvSpPr/>
          <p:nvPr/>
        </p:nvSpPr>
        <p:spPr>
          <a:xfrm>
            <a:off x="7611787" y="407372"/>
            <a:ext cx="2286154" cy="4158053"/>
          </a:xfrm>
          <a:prstGeom prst="roundRect">
            <a:avLst/>
          </a:prstGeom>
          <a:solidFill>
            <a:schemeClr val="accent5">
              <a:lumMod val="20000"/>
              <a:lumOff val="80000"/>
              <a:alpha val="13000"/>
            </a:schemeClr>
          </a:solidFill>
          <a:ln w="9525"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ounded Rectangle 10">
            <a:extLst>
              <a:ext uri="{FF2B5EF4-FFF2-40B4-BE49-F238E27FC236}">
                <a16:creationId xmlns:a16="http://schemas.microsoft.com/office/drawing/2014/main" id="{3F218FFD-BD01-8F50-30F3-769C5B262698}"/>
              </a:ext>
            </a:extLst>
          </p:cNvPr>
          <p:cNvSpPr/>
          <p:nvPr/>
        </p:nvSpPr>
        <p:spPr>
          <a:xfrm>
            <a:off x="10004745" y="401357"/>
            <a:ext cx="2132965" cy="2083672"/>
          </a:xfrm>
          <a:prstGeom prst="roundRect">
            <a:avLst/>
          </a:prstGeom>
          <a:solidFill>
            <a:srgbClr val="D1B71A">
              <a:alpha val="12000"/>
            </a:srgbClr>
          </a:solidFill>
          <a:ln w="9525">
            <a:solidFill>
              <a:srgbClr val="D1B71A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ounded Rectangle 11">
            <a:extLst>
              <a:ext uri="{FF2B5EF4-FFF2-40B4-BE49-F238E27FC236}">
                <a16:creationId xmlns:a16="http://schemas.microsoft.com/office/drawing/2014/main" id="{63580DFF-96CA-40A9-C72A-1B800D10230E}"/>
              </a:ext>
            </a:extLst>
          </p:cNvPr>
          <p:cNvSpPr/>
          <p:nvPr/>
        </p:nvSpPr>
        <p:spPr>
          <a:xfrm>
            <a:off x="207479" y="887003"/>
            <a:ext cx="1889442" cy="645777"/>
          </a:xfrm>
          <a:prstGeom prst="roundRect">
            <a:avLst/>
          </a:prstGeom>
          <a:solidFill>
            <a:srgbClr val="2897FF">
              <a:alpha val="34902"/>
            </a:srgb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ounded Rectangle 12">
            <a:extLst>
              <a:ext uri="{FF2B5EF4-FFF2-40B4-BE49-F238E27FC236}">
                <a16:creationId xmlns:a16="http://schemas.microsoft.com/office/drawing/2014/main" id="{B754C63B-38A5-52F1-B4B7-FBB87FAF28AD}"/>
              </a:ext>
            </a:extLst>
          </p:cNvPr>
          <p:cNvSpPr/>
          <p:nvPr/>
        </p:nvSpPr>
        <p:spPr>
          <a:xfrm>
            <a:off x="207478" y="1725181"/>
            <a:ext cx="1889443" cy="1277700"/>
          </a:xfrm>
          <a:prstGeom prst="roundRect">
            <a:avLst/>
          </a:prstGeom>
          <a:solidFill>
            <a:srgbClr val="23A4FF">
              <a:alpha val="56863"/>
            </a:srgb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0119CD6-C446-DF58-EFB0-7EA208112BF4}"/>
              </a:ext>
            </a:extLst>
          </p:cNvPr>
          <p:cNvSpPr txBox="1"/>
          <p:nvPr/>
        </p:nvSpPr>
        <p:spPr>
          <a:xfrm>
            <a:off x="130884" y="410470"/>
            <a:ext cx="2042632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tx2">
                    <a:lumMod val="75000"/>
                    <a:lumOff val="25000"/>
                  </a:schemeClr>
                </a:solidFill>
              </a:rPr>
              <a:t>Sample Preparatio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861329E-16DD-C80F-3978-6EEBBB0EA261}"/>
              </a:ext>
            </a:extLst>
          </p:cNvPr>
          <p:cNvSpPr txBox="1"/>
          <p:nvPr/>
        </p:nvSpPr>
        <p:spPr>
          <a:xfrm>
            <a:off x="207479" y="856516"/>
            <a:ext cx="1966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eagents &amp; Standards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LC-MS grade solvents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14 isotope standard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9755829-6EBC-650D-A072-FA77C54208BF}"/>
              </a:ext>
            </a:extLst>
          </p:cNvPr>
          <p:cNvSpPr txBox="1"/>
          <p:nvPr/>
        </p:nvSpPr>
        <p:spPr>
          <a:xfrm>
            <a:off x="242171" y="1677352"/>
            <a:ext cx="196603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ample types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20 mouse lung adenocarcinoma tumor samples (Discovery set)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81 mouse lung adenocarcinoma tumor samples </a:t>
            </a:r>
            <a:r>
              <a:rPr lang="en-US" sz="1200"/>
              <a:t>(Validation set)</a:t>
            </a:r>
            <a:endParaRPr lang="en-US" sz="1200" dirty="0"/>
          </a:p>
          <a:p>
            <a:pPr marL="91440" indent="-91440">
              <a:buFont typeface="Arial" panose="020B0604020202020204" pitchFamily="34" charset="0"/>
              <a:buChar char="•"/>
            </a:pPr>
            <a:endParaRPr lang="en-US" sz="1200" dirty="0"/>
          </a:p>
        </p:txBody>
      </p:sp>
      <p:sp>
        <p:nvSpPr>
          <p:cNvPr id="19" name="Rounded Rectangle 18">
            <a:extLst>
              <a:ext uri="{FF2B5EF4-FFF2-40B4-BE49-F238E27FC236}">
                <a16:creationId xmlns:a16="http://schemas.microsoft.com/office/drawing/2014/main" id="{0E8B7FFE-5AE0-9BFA-9CFA-65496E027A78}"/>
              </a:ext>
            </a:extLst>
          </p:cNvPr>
          <p:cNvSpPr/>
          <p:nvPr/>
        </p:nvSpPr>
        <p:spPr>
          <a:xfrm>
            <a:off x="2481955" y="1661581"/>
            <a:ext cx="2099592" cy="775861"/>
          </a:xfrm>
          <a:prstGeom prst="roundRect">
            <a:avLst/>
          </a:prstGeom>
          <a:solidFill>
            <a:srgbClr val="FB9990">
              <a:alpha val="86275"/>
            </a:srgb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F52350A-13BD-E811-6BF3-E9681B20E4A2}"/>
              </a:ext>
            </a:extLst>
          </p:cNvPr>
          <p:cNvSpPr txBox="1"/>
          <p:nvPr/>
        </p:nvSpPr>
        <p:spPr>
          <a:xfrm>
            <a:off x="2521386" y="1270284"/>
            <a:ext cx="2042632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accent2">
                    <a:lumMod val="75000"/>
                  </a:schemeClr>
                </a:solidFill>
              </a:rPr>
              <a:t>Instrument Analysi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CD5871E-5B4B-1E9E-6F01-2DC40FACCF16}"/>
              </a:ext>
            </a:extLst>
          </p:cNvPr>
          <p:cNvSpPr txBox="1"/>
          <p:nvPr/>
        </p:nvSpPr>
        <p:spPr>
          <a:xfrm>
            <a:off x="2550824" y="1660008"/>
            <a:ext cx="21155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UHPLC-HRMS Analysis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HILIC chromatography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Q-</a:t>
            </a:r>
            <a:r>
              <a:rPr lang="en-US" sz="1200" dirty="0" err="1"/>
              <a:t>Exactive</a:t>
            </a:r>
            <a:r>
              <a:rPr lang="en-US" sz="1200" dirty="0"/>
              <a:t> HF (120K)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m/z 65-900 (pos/neg mode)</a:t>
            </a:r>
          </a:p>
        </p:txBody>
      </p:sp>
      <p:sp>
        <p:nvSpPr>
          <p:cNvPr id="22" name="Rounded Rectangle 21">
            <a:extLst>
              <a:ext uri="{FF2B5EF4-FFF2-40B4-BE49-F238E27FC236}">
                <a16:creationId xmlns:a16="http://schemas.microsoft.com/office/drawing/2014/main" id="{BFB60ED4-1926-C852-3E91-AA8DAEDD661C}"/>
              </a:ext>
            </a:extLst>
          </p:cNvPr>
          <p:cNvSpPr/>
          <p:nvPr/>
        </p:nvSpPr>
        <p:spPr>
          <a:xfrm>
            <a:off x="4878206" y="1747048"/>
            <a:ext cx="2037701" cy="540123"/>
          </a:xfrm>
          <a:prstGeom prst="roundRect">
            <a:avLst/>
          </a:prstGeom>
          <a:solidFill>
            <a:schemeClr val="accent6">
              <a:lumMod val="60000"/>
              <a:lumOff val="40000"/>
              <a:alpha val="35467"/>
            </a:scheme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ounded Rectangle 22">
            <a:extLst>
              <a:ext uri="{FF2B5EF4-FFF2-40B4-BE49-F238E27FC236}">
                <a16:creationId xmlns:a16="http://schemas.microsoft.com/office/drawing/2014/main" id="{83DCD0B3-5DD1-7F5B-1710-3CB9BB377D5F}"/>
              </a:ext>
            </a:extLst>
          </p:cNvPr>
          <p:cNvSpPr/>
          <p:nvPr/>
        </p:nvSpPr>
        <p:spPr>
          <a:xfrm>
            <a:off x="4879114" y="2494908"/>
            <a:ext cx="2037701" cy="1058316"/>
          </a:xfrm>
          <a:prstGeom prst="roundRect">
            <a:avLst/>
          </a:prstGeom>
          <a:solidFill>
            <a:schemeClr val="accent6">
              <a:alpha val="48000"/>
            </a:scheme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ounded Rectangle 23">
            <a:extLst>
              <a:ext uri="{FF2B5EF4-FFF2-40B4-BE49-F238E27FC236}">
                <a16:creationId xmlns:a16="http://schemas.microsoft.com/office/drawing/2014/main" id="{2035ACA7-5A41-3B9B-D648-1F4C60EA6C66}"/>
              </a:ext>
            </a:extLst>
          </p:cNvPr>
          <p:cNvSpPr/>
          <p:nvPr/>
        </p:nvSpPr>
        <p:spPr>
          <a:xfrm>
            <a:off x="4884448" y="3747322"/>
            <a:ext cx="2037701" cy="645777"/>
          </a:xfrm>
          <a:prstGeom prst="roundRect">
            <a:avLst/>
          </a:prstGeom>
          <a:solidFill>
            <a:schemeClr val="accent6">
              <a:alpha val="76143"/>
            </a:scheme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210B0CD-A3FF-80FD-27E9-869FC76A9B03}"/>
              </a:ext>
            </a:extLst>
          </p:cNvPr>
          <p:cNvSpPr txBox="1"/>
          <p:nvPr/>
        </p:nvSpPr>
        <p:spPr>
          <a:xfrm>
            <a:off x="4942389" y="1769086"/>
            <a:ext cx="19660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AW → </a:t>
            </a:r>
            <a:r>
              <a:rPr lang="en-US" sz="1200" dirty="0" err="1"/>
              <a:t>mzXML</a:t>
            </a:r>
            <a:r>
              <a:rPr lang="en-US" sz="1200" dirty="0"/>
              <a:t> Conversion</a:t>
            </a:r>
          </a:p>
          <a:p>
            <a:r>
              <a:rPr lang="en-US" sz="1200" dirty="0"/>
              <a:t>(Scripps Raw Converter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A58F5EB-4519-AC5B-641E-F2BA7787C03C}"/>
              </a:ext>
            </a:extLst>
          </p:cNvPr>
          <p:cNvSpPr txBox="1"/>
          <p:nvPr/>
        </p:nvSpPr>
        <p:spPr>
          <a:xfrm>
            <a:off x="4898782" y="2537561"/>
            <a:ext cx="208533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Zmine 3.53 Processing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Peak detection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Retention time alignment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Feature table generation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Identificatio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3F046D8-E4CC-7506-038C-009AC717E362}"/>
              </a:ext>
            </a:extLst>
          </p:cNvPr>
          <p:cNvSpPr txBox="1"/>
          <p:nvPr/>
        </p:nvSpPr>
        <p:spPr>
          <a:xfrm>
            <a:off x="4956111" y="3767549"/>
            <a:ext cx="21720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RON pipeline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Dataset normalization and identification mapping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689D723-7EA7-9F22-2AA5-6D2E5F3D5664}"/>
              </a:ext>
            </a:extLst>
          </p:cNvPr>
          <p:cNvSpPr txBox="1"/>
          <p:nvPr/>
        </p:nvSpPr>
        <p:spPr>
          <a:xfrm>
            <a:off x="5076297" y="1319765"/>
            <a:ext cx="1741763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accent3"/>
                </a:solidFill>
              </a:rPr>
              <a:t>Data Processing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A2B6CAD-EC1E-2764-4E41-6EB2B9B0D147}"/>
              </a:ext>
            </a:extLst>
          </p:cNvPr>
          <p:cNvSpPr txBox="1"/>
          <p:nvPr/>
        </p:nvSpPr>
        <p:spPr>
          <a:xfrm>
            <a:off x="7696891" y="515716"/>
            <a:ext cx="2252279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accent5">
                    <a:lumMod val="50000"/>
                  </a:schemeClr>
                </a:solidFill>
              </a:rPr>
              <a:t>Data QC &amp; Annotation</a:t>
            </a:r>
          </a:p>
        </p:txBody>
      </p:sp>
      <p:sp>
        <p:nvSpPr>
          <p:cNvPr id="32" name="Rounded Rectangle 31">
            <a:extLst>
              <a:ext uri="{FF2B5EF4-FFF2-40B4-BE49-F238E27FC236}">
                <a16:creationId xmlns:a16="http://schemas.microsoft.com/office/drawing/2014/main" id="{FB65071C-909B-7EC9-ED23-1233801A77A4}"/>
              </a:ext>
            </a:extLst>
          </p:cNvPr>
          <p:cNvSpPr/>
          <p:nvPr/>
        </p:nvSpPr>
        <p:spPr>
          <a:xfrm>
            <a:off x="7680811" y="845148"/>
            <a:ext cx="2110718" cy="725369"/>
          </a:xfrm>
          <a:prstGeom prst="roundRect">
            <a:avLst/>
          </a:prstGeom>
          <a:solidFill>
            <a:schemeClr val="accent5">
              <a:lumMod val="75000"/>
              <a:alpha val="9456"/>
            </a:scheme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ounded Rectangle 32">
            <a:extLst>
              <a:ext uri="{FF2B5EF4-FFF2-40B4-BE49-F238E27FC236}">
                <a16:creationId xmlns:a16="http://schemas.microsoft.com/office/drawing/2014/main" id="{37FBB5CE-D30E-B9C1-F59D-2F8CA046F8DD}"/>
              </a:ext>
            </a:extLst>
          </p:cNvPr>
          <p:cNvSpPr/>
          <p:nvPr/>
        </p:nvSpPr>
        <p:spPr>
          <a:xfrm>
            <a:off x="7685639" y="1766711"/>
            <a:ext cx="2110718" cy="725369"/>
          </a:xfrm>
          <a:prstGeom prst="roundRect">
            <a:avLst/>
          </a:prstGeom>
          <a:solidFill>
            <a:schemeClr val="accent5">
              <a:lumMod val="50000"/>
              <a:alpha val="20000"/>
            </a:scheme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ounded Rectangle 33">
            <a:extLst>
              <a:ext uri="{FF2B5EF4-FFF2-40B4-BE49-F238E27FC236}">
                <a16:creationId xmlns:a16="http://schemas.microsoft.com/office/drawing/2014/main" id="{98E1548C-7459-FC16-883B-54CBE5ED6C6D}"/>
              </a:ext>
            </a:extLst>
          </p:cNvPr>
          <p:cNvSpPr/>
          <p:nvPr/>
        </p:nvSpPr>
        <p:spPr>
          <a:xfrm>
            <a:off x="7687382" y="2677880"/>
            <a:ext cx="2110718" cy="725369"/>
          </a:xfrm>
          <a:prstGeom prst="roundRect">
            <a:avLst/>
          </a:prstGeom>
          <a:solidFill>
            <a:schemeClr val="accent5">
              <a:lumMod val="50000"/>
              <a:alpha val="34286"/>
            </a:scheme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ounded Rectangle 34">
            <a:extLst>
              <a:ext uri="{FF2B5EF4-FFF2-40B4-BE49-F238E27FC236}">
                <a16:creationId xmlns:a16="http://schemas.microsoft.com/office/drawing/2014/main" id="{BAF43AF2-6758-DEC3-519E-DD54E76C8E79}"/>
              </a:ext>
            </a:extLst>
          </p:cNvPr>
          <p:cNvSpPr/>
          <p:nvPr/>
        </p:nvSpPr>
        <p:spPr>
          <a:xfrm>
            <a:off x="7701592" y="3596100"/>
            <a:ext cx="2110718" cy="725369"/>
          </a:xfrm>
          <a:prstGeom prst="roundRect">
            <a:avLst/>
          </a:prstGeom>
          <a:solidFill>
            <a:schemeClr val="accent5">
              <a:lumMod val="50000"/>
              <a:alpha val="45288"/>
            </a:scheme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806A009-3024-6DF0-064E-97493A7502AC}"/>
              </a:ext>
            </a:extLst>
          </p:cNvPr>
          <p:cNvSpPr txBox="1"/>
          <p:nvPr/>
        </p:nvSpPr>
        <p:spPr>
          <a:xfrm>
            <a:off x="7749913" y="792333"/>
            <a:ext cx="21267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Quality Filtering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Removing low-quality features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Exclude RT &lt;1/&gt;14 min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9EF2049-C4DE-3CB0-E28D-BA0A2B495C11}"/>
              </a:ext>
            </a:extLst>
          </p:cNvPr>
          <p:cNvSpPr txBox="1"/>
          <p:nvPr/>
        </p:nvSpPr>
        <p:spPr>
          <a:xfrm>
            <a:off x="7690880" y="1818443"/>
            <a:ext cx="21857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T Conversion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Adjust for dead value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Convert to % solvent scale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E2414B6-8D41-D8BF-C2AA-D38759E03446}"/>
              </a:ext>
            </a:extLst>
          </p:cNvPr>
          <p:cNvSpPr txBox="1"/>
          <p:nvPr/>
        </p:nvSpPr>
        <p:spPr>
          <a:xfrm>
            <a:off x="7680120" y="2677870"/>
            <a:ext cx="21857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uplicate Resolution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Prioritize negative ion IDs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3705778-671B-4B5E-520E-754B8675A7AF}"/>
              </a:ext>
            </a:extLst>
          </p:cNvPr>
          <p:cNvSpPr txBox="1"/>
          <p:nvPr/>
        </p:nvSpPr>
        <p:spPr>
          <a:xfrm>
            <a:off x="7764967" y="3653256"/>
            <a:ext cx="19746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etabolite Annotation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HMDB/KEGG/PubChem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Fuzzy mass matching</a:t>
            </a:r>
          </a:p>
        </p:txBody>
      </p:sp>
      <p:sp>
        <p:nvSpPr>
          <p:cNvPr id="43" name="Rounded Rectangle 42">
            <a:extLst>
              <a:ext uri="{FF2B5EF4-FFF2-40B4-BE49-F238E27FC236}">
                <a16:creationId xmlns:a16="http://schemas.microsoft.com/office/drawing/2014/main" id="{850C5C52-68B1-0A6C-DA5B-AD11314A787F}"/>
              </a:ext>
            </a:extLst>
          </p:cNvPr>
          <p:cNvSpPr/>
          <p:nvPr/>
        </p:nvSpPr>
        <p:spPr>
          <a:xfrm>
            <a:off x="10051933" y="725838"/>
            <a:ext cx="2037701" cy="1704951"/>
          </a:xfrm>
          <a:prstGeom prst="roundRect">
            <a:avLst/>
          </a:prstGeom>
          <a:solidFill>
            <a:srgbClr val="FFC000">
              <a:alpha val="35467"/>
            </a:srgb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BDB7204-4A00-F5FB-C78F-4557EFB72F7E}"/>
              </a:ext>
            </a:extLst>
          </p:cNvPr>
          <p:cNvSpPr txBox="1"/>
          <p:nvPr/>
        </p:nvSpPr>
        <p:spPr>
          <a:xfrm>
            <a:off x="10203961" y="375121"/>
            <a:ext cx="192323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A17158"/>
                </a:solidFill>
              </a:rPr>
              <a:t>Machine Learning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84611B80-205A-3324-1B00-4666ED34EE14}"/>
              </a:ext>
            </a:extLst>
          </p:cNvPr>
          <p:cNvCxnSpPr>
            <a:cxnSpLocks/>
          </p:cNvCxnSpPr>
          <p:nvPr/>
        </p:nvCxnSpPr>
        <p:spPr>
          <a:xfrm>
            <a:off x="1075653" y="1532330"/>
            <a:ext cx="0" cy="19285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BBD84DA6-0DF2-F549-E37A-0F33CB0B3E2F}"/>
              </a:ext>
            </a:extLst>
          </p:cNvPr>
          <p:cNvCxnSpPr/>
          <p:nvPr/>
        </p:nvCxnSpPr>
        <p:spPr>
          <a:xfrm>
            <a:off x="5874196" y="2299229"/>
            <a:ext cx="0" cy="19285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0C3AC3BE-E68E-8B9B-90AC-BD62C05FC2B5}"/>
              </a:ext>
            </a:extLst>
          </p:cNvPr>
          <p:cNvCxnSpPr/>
          <p:nvPr/>
        </p:nvCxnSpPr>
        <p:spPr>
          <a:xfrm>
            <a:off x="5883070" y="3567771"/>
            <a:ext cx="0" cy="19285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C97DEA09-99D8-1E61-6783-BABA2B162A4F}"/>
              </a:ext>
            </a:extLst>
          </p:cNvPr>
          <p:cNvCxnSpPr/>
          <p:nvPr/>
        </p:nvCxnSpPr>
        <p:spPr>
          <a:xfrm>
            <a:off x="8723809" y="1576235"/>
            <a:ext cx="0" cy="19285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69A038B8-897B-212B-63F7-26A5D7C87345}"/>
              </a:ext>
            </a:extLst>
          </p:cNvPr>
          <p:cNvCxnSpPr/>
          <p:nvPr/>
        </p:nvCxnSpPr>
        <p:spPr>
          <a:xfrm>
            <a:off x="8723809" y="2485029"/>
            <a:ext cx="0" cy="19285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80AB7A09-1809-AFD6-56DF-4AB8DCE42E37}"/>
              </a:ext>
            </a:extLst>
          </p:cNvPr>
          <p:cNvCxnSpPr/>
          <p:nvPr/>
        </p:nvCxnSpPr>
        <p:spPr>
          <a:xfrm>
            <a:off x="8723809" y="3403249"/>
            <a:ext cx="0" cy="19285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85" name="Group 184">
            <a:extLst>
              <a:ext uri="{FF2B5EF4-FFF2-40B4-BE49-F238E27FC236}">
                <a16:creationId xmlns:a16="http://schemas.microsoft.com/office/drawing/2014/main" id="{846B4CD7-FFA2-1F5C-97D1-E2CE55B8F08D}"/>
              </a:ext>
            </a:extLst>
          </p:cNvPr>
          <p:cNvGrpSpPr/>
          <p:nvPr/>
        </p:nvGrpSpPr>
        <p:grpSpPr>
          <a:xfrm>
            <a:off x="6967882" y="1326692"/>
            <a:ext cx="636978" cy="2689601"/>
            <a:chOff x="6961683" y="1374818"/>
            <a:chExt cx="636978" cy="2689601"/>
          </a:xfrm>
        </p:grpSpPr>
        <p:cxnSp>
          <p:nvCxnSpPr>
            <p:cNvPr id="180" name="Straight Connector 179">
              <a:extLst>
                <a:ext uri="{FF2B5EF4-FFF2-40B4-BE49-F238E27FC236}">
                  <a16:creationId xmlns:a16="http://schemas.microsoft.com/office/drawing/2014/main" id="{BE00DA5F-E821-0FA9-CA8F-4AEACF617077}"/>
                </a:ext>
              </a:extLst>
            </p:cNvPr>
            <p:cNvCxnSpPr/>
            <p:nvPr/>
          </p:nvCxnSpPr>
          <p:spPr>
            <a:xfrm>
              <a:off x="6961683" y="4057492"/>
              <a:ext cx="35557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Straight Connector 181">
              <a:extLst>
                <a:ext uri="{FF2B5EF4-FFF2-40B4-BE49-F238E27FC236}">
                  <a16:creationId xmlns:a16="http://schemas.microsoft.com/office/drawing/2014/main" id="{7C649193-6AD3-4B6C-16D2-2E9697D21EA8}"/>
                </a:ext>
              </a:extLst>
            </p:cNvPr>
            <p:cNvCxnSpPr/>
            <p:nvPr/>
          </p:nvCxnSpPr>
          <p:spPr>
            <a:xfrm flipV="1">
              <a:off x="7326561" y="1374818"/>
              <a:ext cx="0" cy="26896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Straight Arrow Connector 183">
              <a:extLst>
                <a:ext uri="{FF2B5EF4-FFF2-40B4-BE49-F238E27FC236}">
                  <a16:creationId xmlns:a16="http://schemas.microsoft.com/office/drawing/2014/main" id="{2F7D5FA8-8A11-C8B6-0894-6FF152979B69}"/>
                </a:ext>
              </a:extLst>
            </p:cNvPr>
            <p:cNvCxnSpPr/>
            <p:nvPr/>
          </p:nvCxnSpPr>
          <p:spPr>
            <a:xfrm>
              <a:off x="7326561" y="1381745"/>
              <a:ext cx="2721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6" name="Group 185">
            <a:extLst>
              <a:ext uri="{FF2B5EF4-FFF2-40B4-BE49-F238E27FC236}">
                <a16:creationId xmlns:a16="http://schemas.microsoft.com/office/drawing/2014/main" id="{D8CEB02A-4CCA-0378-F5E7-7EBB6C7C48A1}"/>
              </a:ext>
            </a:extLst>
          </p:cNvPr>
          <p:cNvGrpSpPr/>
          <p:nvPr/>
        </p:nvGrpSpPr>
        <p:grpSpPr>
          <a:xfrm rot="5400000">
            <a:off x="9761502" y="2621470"/>
            <a:ext cx="1463515" cy="1190635"/>
            <a:chOff x="5847835" y="1942162"/>
            <a:chExt cx="1092463" cy="2492530"/>
          </a:xfrm>
        </p:grpSpPr>
        <p:cxnSp>
          <p:nvCxnSpPr>
            <p:cNvPr id="188" name="Straight Connector 187">
              <a:extLst>
                <a:ext uri="{FF2B5EF4-FFF2-40B4-BE49-F238E27FC236}">
                  <a16:creationId xmlns:a16="http://schemas.microsoft.com/office/drawing/2014/main" id="{F9A65810-B5BA-DAC0-F753-3B5A24D59B34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694030" y="3188426"/>
              <a:ext cx="249253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Straight Arrow Connector 188">
              <a:extLst>
                <a:ext uri="{FF2B5EF4-FFF2-40B4-BE49-F238E27FC236}">
                  <a16:creationId xmlns:a16="http://schemas.microsoft.com/office/drawing/2014/main" id="{BE53D263-A74E-C148-384F-64A9ED3255AA}"/>
                </a:ext>
              </a:extLst>
            </p:cNvPr>
            <p:cNvCxnSpPr>
              <a:cxnSpLocks/>
              <a:endCxn id="11" idx="2"/>
            </p:cNvCxnSpPr>
            <p:nvPr/>
          </p:nvCxnSpPr>
          <p:spPr>
            <a:xfrm rot="16200000" flipH="1" flipV="1">
              <a:off x="6375906" y="1414091"/>
              <a:ext cx="36321" cy="109246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06" name="Straight Arrow Connector 205">
            <a:extLst>
              <a:ext uri="{FF2B5EF4-FFF2-40B4-BE49-F238E27FC236}">
                <a16:creationId xmlns:a16="http://schemas.microsoft.com/office/drawing/2014/main" id="{261599EF-CECB-1E14-31A0-A1BB019F052A}"/>
              </a:ext>
            </a:extLst>
          </p:cNvPr>
          <p:cNvCxnSpPr/>
          <p:nvPr/>
        </p:nvCxnSpPr>
        <p:spPr>
          <a:xfrm>
            <a:off x="4667413" y="2115141"/>
            <a:ext cx="1631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432B490D-E124-1F04-ACEA-713BAB894F6C}"/>
              </a:ext>
            </a:extLst>
          </p:cNvPr>
          <p:cNvSpPr txBox="1"/>
          <p:nvPr/>
        </p:nvSpPr>
        <p:spPr>
          <a:xfrm>
            <a:off x="10067197" y="861129"/>
            <a:ext cx="219582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redictive Modeling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10 models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12 preprocessors</a:t>
            </a:r>
          </a:p>
          <a:p>
            <a:r>
              <a:rPr lang="en-US" sz="1200" b="1" dirty="0"/>
              <a:t>Model Performance Metrics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Accuracy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ROC-AUC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PR-AUC Yes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PR-AUC No</a:t>
            </a:r>
          </a:p>
        </p:txBody>
      </p:sp>
      <p:sp>
        <p:nvSpPr>
          <p:cNvPr id="2" name="Rounded Rectangle 1">
            <a:extLst>
              <a:ext uri="{FF2B5EF4-FFF2-40B4-BE49-F238E27FC236}">
                <a16:creationId xmlns:a16="http://schemas.microsoft.com/office/drawing/2014/main" id="{2198F0E8-C22A-1E8F-A31E-891857DDDE42}"/>
              </a:ext>
            </a:extLst>
          </p:cNvPr>
          <p:cNvSpPr/>
          <p:nvPr/>
        </p:nvSpPr>
        <p:spPr>
          <a:xfrm>
            <a:off x="212027" y="3198876"/>
            <a:ext cx="1889443" cy="941311"/>
          </a:xfrm>
          <a:prstGeom prst="roundRect">
            <a:avLst/>
          </a:prstGeom>
          <a:solidFill>
            <a:srgbClr val="1E83C8">
              <a:alpha val="57647"/>
            </a:srgbClr>
          </a:solidFill>
          <a:ln w="127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C0D8AE4-D4D3-34DC-12F2-FC60658C6B84}"/>
              </a:ext>
            </a:extLst>
          </p:cNvPr>
          <p:cNvSpPr txBox="1"/>
          <p:nvPr/>
        </p:nvSpPr>
        <p:spPr>
          <a:xfrm>
            <a:off x="227789" y="3148268"/>
            <a:ext cx="196603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iquid-Liquid Extraction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Tissue homogenization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80% MeOH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Concentrate (</a:t>
            </a:r>
            <a:r>
              <a:rPr lang="en-US" sz="1200" dirty="0" err="1"/>
              <a:t>speedvac</a:t>
            </a:r>
            <a:r>
              <a:rPr lang="en-US" sz="1200" dirty="0"/>
              <a:t>)</a:t>
            </a:r>
          </a:p>
          <a:p>
            <a:pPr marL="91440" indent="-91440">
              <a:buFont typeface="Arial" panose="020B0604020202020204" pitchFamily="34" charset="0"/>
              <a:buChar char="•"/>
            </a:pPr>
            <a:r>
              <a:rPr lang="en-US" sz="1200" dirty="0"/>
              <a:t>Centrifugation (18,800xg)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BF698857-E53A-FADD-7666-0C9A23013C7D}"/>
              </a:ext>
            </a:extLst>
          </p:cNvPr>
          <p:cNvCxnSpPr>
            <a:cxnSpLocks/>
          </p:cNvCxnSpPr>
          <p:nvPr/>
        </p:nvCxnSpPr>
        <p:spPr>
          <a:xfrm>
            <a:off x="1075653" y="3002881"/>
            <a:ext cx="0" cy="19285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9" name="Group 8">
            <a:extLst>
              <a:ext uri="{FF2B5EF4-FFF2-40B4-BE49-F238E27FC236}">
                <a16:creationId xmlns:a16="http://schemas.microsoft.com/office/drawing/2014/main" id="{BF9C729C-27E1-909F-489C-2666B8B201D0}"/>
              </a:ext>
            </a:extLst>
          </p:cNvPr>
          <p:cNvGrpSpPr/>
          <p:nvPr/>
        </p:nvGrpSpPr>
        <p:grpSpPr>
          <a:xfrm rot="5400000">
            <a:off x="2275644" y="2445911"/>
            <a:ext cx="1165306" cy="1216372"/>
            <a:chOff x="5851292" y="1942161"/>
            <a:chExt cx="1095518" cy="2546409"/>
          </a:xfrm>
        </p:grpSpPr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2ECA10A-C817-609C-FE2A-27DEEB32DC0D}"/>
                </a:ext>
              </a:extLst>
            </p:cNvPr>
            <p:cNvCxnSpPr>
              <a:cxnSpLocks/>
            </p:cNvCxnSpPr>
            <p:nvPr/>
          </p:nvCxnSpPr>
          <p:spPr>
            <a:xfrm rot="16200000" flipV="1">
              <a:off x="5667092" y="3215365"/>
              <a:ext cx="2546409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7AA3B3F2-B4BE-8B86-799A-593A836400E3}"/>
                </a:ext>
              </a:extLst>
            </p:cNvPr>
            <p:cNvCxnSpPr>
              <a:cxnSpLocks/>
            </p:cNvCxnSpPr>
            <p:nvPr/>
          </p:nvCxnSpPr>
          <p:spPr>
            <a:xfrm rot="16200000" flipV="1">
              <a:off x="6399051" y="1394404"/>
              <a:ext cx="0" cy="109551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7091635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36</TotalTime>
  <Words>160</Words>
  <Application>Microsoft Macintosh PowerPoint</Application>
  <PresentationFormat>Widescreen</PresentationFormat>
  <Paragraphs>4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konnen, Yonatan Ayalew</dc:creator>
  <cp:lastModifiedBy>Mekonnen, Yonatan Ayalew</cp:lastModifiedBy>
  <cp:revision>10</cp:revision>
  <dcterms:created xsi:type="dcterms:W3CDTF">2025-06-09T17:07:54Z</dcterms:created>
  <dcterms:modified xsi:type="dcterms:W3CDTF">2025-08-25T17:26:31Z</dcterms:modified>
</cp:coreProperties>
</file>